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646025" cy="5054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4434A"/>
    <a:srgbClr val="CA3C44"/>
    <a:srgbClr val="FFCAC4"/>
    <a:srgbClr val="FFEAE7"/>
    <a:srgbClr val="2E2E2E"/>
    <a:srgbClr val="0099FF"/>
    <a:srgbClr val="33CCCC"/>
    <a:srgbClr val="99CCFF"/>
    <a:srgbClr val="0066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78" d="100"/>
          <a:sy n="78" d="100"/>
        </p:scale>
        <p:origin x="270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80753" y="827223"/>
            <a:ext cx="9484519" cy="1759750"/>
          </a:xfrm>
        </p:spPr>
        <p:txBody>
          <a:bodyPr anchor="b"/>
          <a:lstStyle>
            <a:lvl1pPr algn="ctr">
              <a:defRPr sz="4422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80753" y="2654835"/>
            <a:ext cx="9484519" cy="1220358"/>
          </a:xfrm>
        </p:spPr>
        <p:txBody>
          <a:bodyPr/>
          <a:lstStyle>
            <a:lvl1pPr marL="0" indent="0" algn="ctr">
              <a:buNone/>
              <a:defRPr sz="1769"/>
            </a:lvl1pPr>
            <a:lvl2pPr marL="336956" indent="0" algn="ctr">
              <a:buNone/>
              <a:defRPr sz="1474"/>
            </a:lvl2pPr>
            <a:lvl3pPr marL="673913" indent="0" algn="ctr">
              <a:buNone/>
              <a:defRPr sz="1327"/>
            </a:lvl3pPr>
            <a:lvl4pPr marL="1010869" indent="0" algn="ctr">
              <a:buNone/>
              <a:defRPr sz="1179"/>
            </a:lvl4pPr>
            <a:lvl5pPr marL="1347826" indent="0" algn="ctr">
              <a:buNone/>
              <a:defRPr sz="1179"/>
            </a:lvl5pPr>
            <a:lvl6pPr marL="1684782" indent="0" algn="ctr">
              <a:buNone/>
              <a:defRPr sz="1179"/>
            </a:lvl6pPr>
            <a:lvl7pPr marL="2021738" indent="0" algn="ctr">
              <a:buNone/>
              <a:defRPr sz="1179"/>
            </a:lvl7pPr>
            <a:lvl8pPr marL="2358695" indent="0" algn="ctr">
              <a:buNone/>
              <a:defRPr sz="1179"/>
            </a:lvl8pPr>
            <a:lvl9pPr marL="2695651" indent="0" algn="ctr">
              <a:buNone/>
              <a:defRPr sz="1179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12018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48374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49812" y="269111"/>
            <a:ext cx="2726799" cy="4283540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9414" y="269111"/>
            <a:ext cx="8022322" cy="4283540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58968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57283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2828" y="1260141"/>
            <a:ext cx="10907197" cy="2102573"/>
          </a:xfrm>
        </p:spPr>
        <p:txBody>
          <a:bodyPr anchor="b"/>
          <a:lstStyle>
            <a:lvl1pPr>
              <a:defRPr sz="4422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2828" y="3382605"/>
            <a:ext cx="10907197" cy="1105693"/>
          </a:xfrm>
        </p:spPr>
        <p:txBody>
          <a:bodyPr/>
          <a:lstStyle>
            <a:lvl1pPr marL="0" indent="0">
              <a:buNone/>
              <a:defRPr sz="1769">
                <a:solidFill>
                  <a:schemeClr val="tx1">
                    <a:tint val="75000"/>
                  </a:schemeClr>
                </a:solidFill>
              </a:defRPr>
            </a:lvl1pPr>
            <a:lvl2pPr marL="336956" indent="0">
              <a:buNone/>
              <a:defRPr sz="1474">
                <a:solidFill>
                  <a:schemeClr val="tx1">
                    <a:tint val="75000"/>
                  </a:schemeClr>
                </a:solidFill>
              </a:defRPr>
            </a:lvl2pPr>
            <a:lvl3pPr marL="673913" indent="0">
              <a:buNone/>
              <a:defRPr sz="1327">
                <a:solidFill>
                  <a:schemeClr val="tx1">
                    <a:tint val="75000"/>
                  </a:schemeClr>
                </a:solidFill>
              </a:defRPr>
            </a:lvl3pPr>
            <a:lvl4pPr marL="1010869" indent="0">
              <a:buNone/>
              <a:defRPr sz="1179">
                <a:solidFill>
                  <a:schemeClr val="tx1">
                    <a:tint val="75000"/>
                  </a:schemeClr>
                </a:solidFill>
              </a:defRPr>
            </a:lvl4pPr>
            <a:lvl5pPr marL="1347826" indent="0">
              <a:buNone/>
              <a:defRPr sz="1179">
                <a:solidFill>
                  <a:schemeClr val="tx1">
                    <a:tint val="75000"/>
                  </a:schemeClr>
                </a:solidFill>
              </a:defRPr>
            </a:lvl5pPr>
            <a:lvl6pPr marL="1684782" indent="0">
              <a:buNone/>
              <a:defRPr sz="1179">
                <a:solidFill>
                  <a:schemeClr val="tx1">
                    <a:tint val="75000"/>
                  </a:schemeClr>
                </a:solidFill>
              </a:defRPr>
            </a:lvl6pPr>
            <a:lvl7pPr marL="2021738" indent="0">
              <a:buNone/>
              <a:defRPr sz="1179">
                <a:solidFill>
                  <a:schemeClr val="tx1">
                    <a:tint val="75000"/>
                  </a:schemeClr>
                </a:solidFill>
              </a:defRPr>
            </a:lvl7pPr>
            <a:lvl8pPr marL="2358695" indent="0">
              <a:buNone/>
              <a:defRPr sz="1179">
                <a:solidFill>
                  <a:schemeClr val="tx1">
                    <a:tint val="75000"/>
                  </a:schemeClr>
                </a:solidFill>
              </a:defRPr>
            </a:lvl8pPr>
            <a:lvl9pPr marL="2695651" indent="0">
              <a:buNone/>
              <a:defRPr sz="117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90243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9414" y="1345553"/>
            <a:ext cx="5374561" cy="3207097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02050" y="1345553"/>
            <a:ext cx="5374561" cy="3207097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51054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1061" y="269111"/>
            <a:ext cx="10907197" cy="976989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1062" y="1239079"/>
            <a:ext cx="5349861" cy="607254"/>
          </a:xfrm>
        </p:spPr>
        <p:txBody>
          <a:bodyPr anchor="b"/>
          <a:lstStyle>
            <a:lvl1pPr marL="0" indent="0">
              <a:buNone/>
              <a:defRPr sz="1769" b="1"/>
            </a:lvl1pPr>
            <a:lvl2pPr marL="336956" indent="0">
              <a:buNone/>
              <a:defRPr sz="1474" b="1"/>
            </a:lvl2pPr>
            <a:lvl3pPr marL="673913" indent="0">
              <a:buNone/>
              <a:defRPr sz="1327" b="1"/>
            </a:lvl3pPr>
            <a:lvl4pPr marL="1010869" indent="0">
              <a:buNone/>
              <a:defRPr sz="1179" b="1"/>
            </a:lvl4pPr>
            <a:lvl5pPr marL="1347826" indent="0">
              <a:buNone/>
              <a:defRPr sz="1179" b="1"/>
            </a:lvl5pPr>
            <a:lvl6pPr marL="1684782" indent="0">
              <a:buNone/>
              <a:defRPr sz="1179" b="1"/>
            </a:lvl6pPr>
            <a:lvl7pPr marL="2021738" indent="0">
              <a:buNone/>
              <a:defRPr sz="1179" b="1"/>
            </a:lvl7pPr>
            <a:lvl8pPr marL="2358695" indent="0">
              <a:buNone/>
              <a:defRPr sz="1179" b="1"/>
            </a:lvl8pPr>
            <a:lvl9pPr marL="2695651" indent="0">
              <a:buNone/>
              <a:defRPr sz="117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71062" y="1846333"/>
            <a:ext cx="5349861" cy="271567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02050" y="1239079"/>
            <a:ext cx="5376208" cy="607254"/>
          </a:xfrm>
        </p:spPr>
        <p:txBody>
          <a:bodyPr anchor="b"/>
          <a:lstStyle>
            <a:lvl1pPr marL="0" indent="0">
              <a:buNone/>
              <a:defRPr sz="1769" b="1"/>
            </a:lvl1pPr>
            <a:lvl2pPr marL="336956" indent="0">
              <a:buNone/>
              <a:defRPr sz="1474" b="1"/>
            </a:lvl2pPr>
            <a:lvl3pPr marL="673913" indent="0">
              <a:buNone/>
              <a:defRPr sz="1327" b="1"/>
            </a:lvl3pPr>
            <a:lvl4pPr marL="1010869" indent="0">
              <a:buNone/>
              <a:defRPr sz="1179" b="1"/>
            </a:lvl4pPr>
            <a:lvl5pPr marL="1347826" indent="0">
              <a:buNone/>
              <a:defRPr sz="1179" b="1"/>
            </a:lvl5pPr>
            <a:lvl6pPr marL="1684782" indent="0">
              <a:buNone/>
              <a:defRPr sz="1179" b="1"/>
            </a:lvl6pPr>
            <a:lvl7pPr marL="2021738" indent="0">
              <a:buNone/>
              <a:defRPr sz="1179" b="1"/>
            </a:lvl7pPr>
            <a:lvl8pPr marL="2358695" indent="0">
              <a:buNone/>
              <a:defRPr sz="1179" b="1"/>
            </a:lvl8pPr>
            <a:lvl9pPr marL="2695651" indent="0">
              <a:buNone/>
              <a:defRPr sz="117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02050" y="1846333"/>
            <a:ext cx="5376208" cy="271567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55079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684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36179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1062" y="336973"/>
            <a:ext cx="4078672" cy="1179407"/>
          </a:xfrm>
        </p:spPr>
        <p:txBody>
          <a:bodyPr anchor="b"/>
          <a:lstStyle>
            <a:lvl1pPr>
              <a:defRPr sz="235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76208" y="727769"/>
            <a:ext cx="6402050" cy="3592042"/>
          </a:xfrm>
        </p:spPr>
        <p:txBody>
          <a:bodyPr/>
          <a:lstStyle>
            <a:lvl1pPr>
              <a:defRPr sz="2358"/>
            </a:lvl1pPr>
            <a:lvl2pPr>
              <a:defRPr sz="2064"/>
            </a:lvl2pPr>
            <a:lvl3pPr>
              <a:defRPr sz="1769"/>
            </a:lvl3pPr>
            <a:lvl4pPr>
              <a:defRPr sz="1474"/>
            </a:lvl4pPr>
            <a:lvl5pPr>
              <a:defRPr sz="1474"/>
            </a:lvl5pPr>
            <a:lvl6pPr>
              <a:defRPr sz="1474"/>
            </a:lvl6pPr>
            <a:lvl7pPr>
              <a:defRPr sz="1474"/>
            </a:lvl7pPr>
            <a:lvl8pPr>
              <a:defRPr sz="1474"/>
            </a:lvl8pPr>
            <a:lvl9pPr>
              <a:defRPr sz="1474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71062" y="1516380"/>
            <a:ext cx="4078672" cy="2809282"/>
          </a:xfrm>
        </p:spPr>
        <p:txBody>
          <a:bodyPr/>
          <a:lstStyle>
            <a:lvl1pPr marL="0" indent="0">
              <a:buNone/>
              <a:defRPr sz="1179"/>
            </a:lvl1pPr>
            <a:lvl2pPr marL="336956" indent="0">
              <a:buNone/>
              <a:defRPr sz="1032"/>
            </a:lvl2pPr>
            <a:lvl3pPr marL="673913" indent="0">
              <a:buNone/>
              <a:defRPr sz="884"/>
            </a:lvl3pPr>
            <a:lvl4pPr marL="1010869" indent="0">
              <a:buNone/>
              <a:defRPr sz="737"/>
            </a:lvl4pPr>
            <a:lvl5pPr marL="1347826" indent="0">
              <a:buNone/>
              <a:defRPr sz="737"/>
            </a:lvl5pPr>
            <a:lvl6pPr marL="1684782" indent="0">
              <a:buNone/>
              <a:defRPr sz="737"/>
            </a:lvl6pPr>
            <a:lvl7pPr marL="2021738" indent="0">
              <a:buNone/>
              <a:defRPr sz="737"/>
            </a:lvl7pPr>
            <a:lvl8pPr marL="2358695" indent="0">
              <a:buNone/>
              <a:defRPr sz="737"/>
            </a:lvl8pPr>
            <a:lvl9pPr marL="2695651" indent="0">
              <a:buNone/>
              <a:defRPr sz="737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57618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1062" y="336973"/>
            <a:ext cx="4078672" cy="1179407"/>
          </a:xfrm>
        </p:spPr>
        <p:txBody>
          <a:bodyPr anchor="b"/>
          <a:lstStyle>
            <a:lvl1pPr>
              <a:defRPr sz="235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76208" y="727769"/>
            <a:ext cx="6402050" cy="3592042"/>
          </a:xfrm>
        </p:spPr>
        <p:txBody>
          <a:bodyPr anchor="t"/>
          <a:lstStyle>
            <a:lvl1pPr marL="0" indent="0">
              <a:buNone/>
              <a:defRPr sz="2358"/>
            </a:lvl1pPr>
            <a:lvl2pPr marL="336956" indent="0">
              <a:buNone/>
              <a:defRPr sz="2064"/>
            </a:lvl2pPr>
            <a:lvl3pPr marL="673913" indent="0">
              <a:buNone/>
              <a:defRPr sz="1769"/>
            </a:lvl3pPr>
            <a:lvl4pPr marL="1010869" indent="0">
              <a:buNone/>
              <a:defRPr sz="1474"/>
            </a:lvl4pPr>
            <a:lvl5pPr marL="1347826" indent="0">
              <a:buNone/>
              <a:defRPr sz="1474"/>
            </a:lvl5pPr>
            <a:lvl6pPr marL="1684782" indent="0">
              <a:buNone/>
              <a:defRPr sz="1474"/>
            </a:lvl6pPr>
            <a:lvl7pPr marL="2021738" indent="0">
              <a:buNone/>
              <a:defRPr sz="1474"/>
            </a:lvl7pPr>
            <a:lvl8pPr marL="2358695" indent="0">
              <a:buNone/>
              <a:defRPr sz="1474"/>
            </a:lvl8pPr>
            <a:lvl9pPr marL="2695651" indent="0">
              <a:buNone/>
              <a:defRPr sz="1474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71062" y="1516380"/>
            <a:ext cx="4078672" cy="2809282"/>
          </a:xfrm>
        </p:spPr>
        <p:txBody>
          <a:bodyPr/>
          <a:lstStyle>
            <a:lvl1pPr marL="0" indent="0">
              <a:buNone/>
              <a:defRPr sz="1179"/>
            </a:lvl1pPr>
            <a:lvl2pPr marL="336956" indent="0">
              <a:buNone/>
              <a:defRPr sz="1032"/>
            </a:lvl2pPr>
            <a:lvl3pPr marL="673913" indent="0">
              <a:buNone/>
              <a:defRPr sz="884"/>
            </a:lvl3pPr>
            <a:lvl4pPr marL="1010869" indent="0">
              <a:buNone/>
              <a:defRPr sz="737"/>
            </a:lvl4pPr>
            <a:lvl5pPr marL="1347826" indent="0">
              <a:buNone/>
              <a:defRPr sz="737"/>
            </a:lvl5pPr>
            <a:lvl6pPr marL="1684782" indent="0">
              <a:buNone/>
              <a:defRPr sz="737"/>
            </a:lvl6pPr>
            <a:lvl7pPr marL="2021738" indent="0">
              <a:buNone/>
              <a:defRPr sz="737"/>
            </a:lvl7pPr>
            <a:lvl8pPr marL="2358695" indent="0">
              <a:buNone/>
              <a:defRPr sz="737"/>
            </a:lvl8pPr>
            <a:lvl9pPr marL="2695651" indent="0">
              <a:buNone/>
              <a:defRPr sz="737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40592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9414" y="269111"/>
            <a:ext cx="10907197" cy="9769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9414" y="1345553"/>
            <a:ext cx="10907197" cy="32070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9414" y="4684866"/>
            <a:ext cx="2845356" cy="26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1732CA-6725-4EEC-8A32-C72317D275C9}" type="datetimeFigureOut">
              <a:rPr lang="pt-BR" smtClean="0"/>
              <a:t>23/08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88996" y="4684866"/>
            <a:ext cx="4268033" cy="26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931255" y="4684866"/>
            <a:ext cx="2845356" cy="26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47F69-36D9-4F15-AD65-D7A98959EE4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46076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73913" rtl="0" eaLnBrk="1" latinLnBrk="0" hangingPunct="1">
        <a:lnSpc>
          <a:spcPct val="90000"/>
        </a:lnSpc>
        <a:spcBef>
          <a:spcPct val="0"/>
        </a:spcBef>
        <a:buNone/>
        <a:defRPr sz="324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8478" indent="-168478" algn="l" defTabSz="673913" rtl="0" eaLnBrk="1" latinLnBrk="0" hangingPunct="1">
        <a:lnSpc>
          <a:spcPct val="90000"/>
        </a:lnSpc>
        <a:spcBef>
          <a:spcPts val="737"/>
        </a:spcBef>
        <a:buFont typeface="Arial" panose="020B0604020202020204" pitchFamily="34" charset="0"/>
        <a:buChar char="•"/>
        <a:defRPr sz="2064" kern="1200">
          <a:solidFill>
            <a:schemeClr val="tx1"/>
          </a:solidFill>
          <a:latin typeface="+mn-lt"/>
          <a:ea typeface="+mn-ea"/>
          <a:cs typeface="+mn-cs"/>
        </a:defRPr>
      </a:lvl1pPr>
      <a:lvl2pPr marL="505435" indent="-168478" algn="l" defTabSz="673913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769" kern="1200">
          <a:solidFill>
            <a:schemeClr val="tx1"/>
          </a:solidFill>
          <a:latin typeface="+mn-lt"/>
          <a:ea typeface="+mn-ea"/>
          <a:cs typeface="+mn-cs"/>
        </a:defRPr>
      </a:lvl2pPr>
      <a:lvl3pPr marL="842391" indent="-168478" algn="l" defTabSz="673913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474" kern="1200">
          <a:solidFill>
            <a:schemeClr val="tx1"/>
          </a:solidFill>
          <a:latin typeface="+mn-lt"/>
          <a:ea typeface="+mn-ea"/>
          <a:cs typeface="+mn-cs"/>
        </a:defRPr>
      </a:lvl3pPr>
      <a:lvl4pPr marL="1179347" indent="-168478" algn="l" defTabSz="673913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7" kern="1200">
          <a:solidFill>
            <a:schemeClr val="tx1"/>
          </a:solidFill>
          <a:latin typeface="+mn-lt"/>
          <a:ea typeface="+mn-ea"/>
          <a:cs typeface="+mn-cs"/>
        </a:defRPr>
      </a:lvl4pPr>
      <a:lvl5pPr marL="1516304" indent="-168478" algn="l" defTabSz="673913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7" kern="1200">
          <a:solidFill>
            <a:schemeClr val="tx1"/>
          </a:solidFill>
          <a:latin typeface="+mn-lt"/>
          <a:ea typeface="+mn-ea"/>
          <a:cs typeface="+mn-cs"/>
        </a:defRPr>
      </a:lvl5pPr>
      <a:lvl6pPr marL="1853260" indent="-168478" algn="l" defTabSz="673913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7" kern="1200">
          <a:solidFill>
            <a:schemeClr val="tx1"/>
          </a:solidFill>
          <a:latin typeface="+mn-lt"/>
          <a:ea typeface="+mn-ea"/>
          <a:cs typeface="+mn-cs"/>
        </a:defRPr>
      </a:lvl6pPr>
      <a:lvl7pPr marL="2190217" indent="-168478" algn="l" defTabSz="673913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7" kern="1200">
          <a:solidFill>
            <a:schemeClr val="tx1"/>
          </a:solidFill>
          <a:latin typeface="+mn-lt"/>
          <a:ea typeface="+mn-ea"/>
          <a:cs typeface="+mn-cs"/>
        </a:defRPr>
      </a:lvl7pPr>
      <a:lvl8pPr marL="2527173" indent="-168478" algn="l" defTabSz="673913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7" kern="1200">
          <a:solidFill>
            <a:schemeClr val="tx1"/>
          </a:solidFill>
          <a:latin typeface="+mn-lt"/>
          <a:ea typeface="+mn-ea"/>
          <a:cs typeface="+mn-cs"/>
        </a:defRPr>
      </a:lvl8pPr>
      <a:lvl9pPr marL="2864129" indent="-168478" algn="l" defTabSz="673913" rtl="0" eaLnBrk="1" latinLnBrk="0" hangingPunct="1">
        <a:lnSpc>
          <a:spcPct val="90000"/>
        </a:lnSpc>
        <a:spcBef>
          <a:spcPts val="369"/>
        </a:spcBef>
        <a:buFont typeface="Arial" panose="020B0604020202020204" pitchFamily="34" charset="0"/>
        <a:buChar char="•"/>
        <a:defRPr sz="132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3913" rtl="0" eaLnBrk="1" latinLnBrk="0" hangingPunct="1">
        <a:defRPr sz="1327" kern="1200">
          <a:solidFill>
            <a:schemeClr val="tx1"/>
          </a:solidFill>
          <a:latin typeface="+mn-lt"/>
          <a:ea typeface="+mn-ea"/>
          <a:cs typeface="+mn-cs"/>
        </a:defRPr>
      </a:lvl1pPr>
      <a:lvl2pPr marL="336956" algn="l" defTabSz="673913" rtl="0" eaLnBrk="1" latinLnBrk="0" hangingPunct="1">
        <a:defRPr sz="1327" kern="1200">
          <a:solidFill>
            <a:schemeClr val="tx1"/>
          </a:solidFill>
          <a:latin typeface="+mn-lt"/>
          <a:ea typeface="+mn-ea"/>
          <a:cs typeface="+mn-cs"/>
        </a:defRPr>
      </a:lvl2pPr>
      <a:lvl3pPr marL="673913" algn="l" defTabSz="673913" rtl="0" eaLnBrk="1" latinLnBrk="0" hangingPunct="1">
        <a:defRPr sz="1327" kern="1200">
          <a:solidFill>
            <a:schemeClr val="tx1"/>
          </a:solidFill>
          <a:latin typeface="+mn-lt"/>
          <a:ea typeface="+mn-ea"/>
          <a:cs typeface="+mn-cs"/>
        </a:defRPr>
      </a:lvl3pPr>
      <a:lvl4pPr marL="1010869" algn="l" defTabSz="673913" rtl="0" eaLnBrk="1" latinLnBrk="0" hangingPunct="1">
        <a:defRPr sz="1327" kern="1200">
          <a:solidFill>
            <a:schemeClr val="tx1"/>
          </a:solidFill>
          <a:latin typeface="+mn-lt"/>
          <a:ea typeface="+mn-ea"/>
          <a:cs typeface="+mn-cs"/>
        </a:defRPr>
      </a:lvl4pPr>
      <a:lvl5pPr marL="1347826" algn="l" defTabSz="673913" rtl="0" eaLnBrk="1" latinLnBrk="0" hangingPunct="1">
        <a:defRPr sz="1327" kern="1200">
          <a:solidFill>
            <a:schemeClr val="tx1"/>
          </a:solidFill>
          <a:latin typeface="+mn-lt"/>
          <a:ea typeface="+mn-ea"/>
          <a:cs typeface="+mn-cs"/>
        </a:defRPr>
      </a:lvl5pPr>
      <a:lvl6pPr marL="1684782" algn="l" defTabSz="673913" rtl="0" eaLnBrk="1" latinLnBrk="0" hangingPunct="1">
        <a:defRPr sz="1327" kern="1200">
          <a:solidFill>
            <a:schemeClr val="tx1"/>
          </a:solidFill>
          <a:latin typeface="+mn-lt"/>
          <a:ea typeface="+mn-ea"/>
          <a:cs typeface="+mn-cs"/>
        </a:defRPr>
      </a:lvl6pPr>
      <a:lvl7pPr marL="2021738" algn="l" defTabSz="673913" rtl="0" eaLnBrk="1" latinLnBrk="0" hangingPunct="1">
        <a:defRPr sz="1327" kern="1200">
          <a:solidFill>
            <a:schemeClr val="tx1"/>
          </a:solidFill>
          <a:latin typeface="+mn-lt"/>
          <a:ea typeface="+mn-ea"/>
          <a:cs typeface="+mn-cs"/>
        </a:defRPr>
      </a:lvl7pPr>
      <a:lvl8pPr marL="2358695" algn="l" defTabSz="673913" rtl="0" eaLnBrk="1" latinLnBrk="0" hangingPunct="1">
        <a:defRPr sz="1327" kern="1200">
          <a:solidFill>
            <a:schemeClr val="tx1"/>
          </a:solidFill>
          <a:latin typeface="+mn-lt"/>
          <a:ea typeface="+mn-ea"/>
          <a:cs typeface="+mn-cs"/>
        </a:defRPr>
      </a:lvl8pPr>
      <a:lvl9pPr marL="2695651" algn="l" defTabSz="673913" rtl="0" eaLnBrk="1" latinLnBrk="0" hangingPunct="1">
        <a:defRPr sz="132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openxmlformats.org/officeDocument/2006/relationships/image" Target="../media/image3.png"/><Relationship Id="rId12" Type="http://schemas.openxmlformats.org/officeDocument/2006/relationships/image" Target="../media/image8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hyperlink" Target="https://svgsilh.com/ar/image/2952553.html" TargetMode="External"/><Relationship Id="rId11" Type="http://schemas.openxmlformats.org/officeDocument/2006/relationships/image" Target="../media/image7.png"/><Relationship Id="rId5" Type="http://schemas.openxmlformats.org/officeDocument/2006/relationships/image" Target="../media/image2.png"/><Relationship Id="rId10" Type="http://schemas.openxmlformats.org/officeDocument/2006/relationships/image" Target="../media/image6.png"/><Relationship Id="rId4" Type="http://schemas.openxmlformats.org/officeDocument/2006/relationships/hyperlink" Target="https://pixabay.com/es/silueta-caballo-galope-ecuestre-3350708/" TargetMode="External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ângulo 5">
            <a:extLst>
              <a:ext uri="{FF2B5EF4-FFF2-40B4-BE49-F238E27FC236}">
                <a16:creationId xmlns:a16="http://schemas.microsoft.com/office/drawing/2014/main" id="{F77777C2-3DC1-5501-92DD-D9688C0CCD54}"/>
              </a:ext>
            </a:extLst>
          </p:cNvPr>
          <p:cNvSpPr/>
          <p:nvPr/>
        </p:nvSpPr>
        <p:spPr>
          <a:xfrm>
            <a:off x="-4" y="643254"/>
            <a:ext cx="12646025" cy="3825077"/>
          </a:xfrm>
          <a:prstGeom prst="rect">
            <a:avLst/>
          </a:prstGeom>
          <a:solidFill>
            <a:srgbClr val="FFEAE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dirty="0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tângulo 6">
            <a:extLst>
              <a:ext uri="{FF2B5EF4-FFF2-40B4-BE49-F238E27FC236}">
                <a16:creationId xmlns:a16="http://schemas.microsoft.com/office/drawing/2014/main" id="{AB244D35-4E8D-16B9-74E2-6BAE4095A484}"/>
              </a:ext>
            </a:extLst>
          </p:cNvPr>
          <p:cNvSpPr/>
          <p:nvPr/>
        </p:nvSpPr>
        <p:spPr>
          <a:xfrm>
            <a:off x="0" y="0"/>
            <a:ext cx="12646025" cy="656590"/>
          </a:xfrm>
          <a:prstGeom prst="rect">
            <a:avLst/>
          </a:prstGeom>
          <a:solidFill>
            <a:srgbClr val="D4434A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tângulo 7">
            <a:extLst>
              <a:ext uri="{FF2B5EF4-FFF2-40B4-BE49-F238E27FC236}">
                <a16:creationId xmlns:a16="http://schemas.microsoft.com/office/drawing/2014/main" id="{A47CE3BB-D6B3-514E-2895-1E505F4EBE78}"/>
              </a:ext>
            </a:extLst>
          </p:cNvPr>
          <p:cNvSpPr/>
          <p:nvPr/>
        </p:nvSpPr>
        <p:spPr>
          <a:xfrm>
            <a:off x="-2" y="4401820"/>
            <a:ext cx="12646025" cy="656590"/>
          </a:xfrm>
          <a:prstGeom prst="rect">
            <a:avLst/>
          </a:prstGeom>
          <a:solidFill>
            <a:srgbClr val="FFCAC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72ED4E5A-6100-A021-6E36-BC4D9F08CE23}"/>
              </a:ext>
            </a:extLst>
          </p:cNvPr>
          <p:cNvSpPr txBox="1"/>
          <p:nvPr/>
        </p:nvSpPr>
        <p:spPr>
          <a:xfrm>
            <a:off x="-3" y="148911"/>
            <a:ext cx="1264602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kern="0" dirty="0">
                <a:solidFill>
                  <a:schemeClr val="bg1"/>
                </a:solidFill>
                <a:effectLst/>
                <a:latin typeface="Arial Nova" panose="020F0502020204030204" pitchFamily="34" charset="0"/>
                <a:ea typeface="Times New Roman" panose="02020603050405020304" pitchFamily="18" charset="0"/>
                <a:cs typeface="Aldhabi" panose="020F0502020204030204" pitchFamily="2" charset="-78"/>
              </a:rPr>
              <a:t>BIOCOMPATIBILITY OF HYDROGEL DERIVED FROM EQUINE TENDON EXTRACELLULAR MATRIX </a:t>
            </a:r>
            <a:r>
              <a:rPr lang="en-US" i="1" kern="0" dirty="0">
                <a:solidFill>
                  <a:schemeClr val="bg1"/>
                </a:solidFill>
                <a:effectLst/>
                <a:latin typeface="Arial Nova" panose="020F0502020204030204" pitchFamily="34" charset="0"/>
                <a:ea typeface="Times New Roman" panose="02020603050405020304" pitchFamily="18" charset="0"/>
                <a:cs typeface="Aldhabi" panose="020F0502020204030204" pitchFamily="2" charset="-78"/>
              </a:rPr>
              <a:t>IN VIVO</a:t>
            </a:r>
            <a:endParaRPr lang="pt-BR" kern="100" dirty="0">
              <a:solidFill>
                <a:schemeClr val="bg1"/>
              </a:solidFill>
              <a:effectLst/>
              <a:latin typeface="Arial Nova" panose="020F0502020204030204" pitchFamily="34" charset="0"/>
              <a:ea typeface="Calibri" panose="020F0502020204030204" pitchFamily="34" charset="0"/>
              <a:cs typeface="Aldhabi" panose="020F0502020204030204" pitchFamily="2" charset="-78"/>
            </a:endParaRP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C03DB1DB-5545-2A14-5D15-F05C4A02397E}"/>
              </a:ext>
            </a:extLst>
          </p:cNvPr>
          <p:cNvSpPr txBox="1"/>
          <p:nvPr/>
        </p:nvSpPr>
        <p:spPr>
          <a:xfrm>
            <a:off x="0" y="4437484"/>
            <a:ext cx="1264602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kern="0" dirty="0"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CLUSION: The implantation of the allogeneic biomaterial resulted in an initial inflammatory response. However, the hydrogel successfully integrated into the adjacent tissue without any residual inflammation, thereby confirming its biocompatibility and </a:t>
            </a:r>
            <a:r>
              <a:rPr lang="en-US" sz="1500" kern="0" dirty="0" err="1"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ioabsorbability</a:t>
            </a:r>
            <a:r>
              <a:rPr lang="en-US" sz="1500" kern="0" dirty="0"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endParaRPr lang="pt-BR" sz="1500" dirty="0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Imagem 28" descr="Forma&#10;&#10;Descrição gerada automaticamente com confiança média">
            <a:extLst>
              <a:ext uri="{FF2B5EF4-FFF2-40B4-BE49-F238E27FC236}">
                <a16:creationId xmlns:a16="http://schemas.microsoft.com/office/drawing/2014/main" id="{FB48AF53-B31E-43E0-C489-99C7387F0451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rgbClr val="C00000">
                <a:tint val="45000"/>
                <a:satMod val="40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artisticPhotocopy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tretch>
            <a:fillRect/>
          </a:stretch>
        </p:blipFill>
        <p:spPr>
          <a:xfrm>
            <a:off x="274927" y="705939"/>
            <a:ext cx="1308068" cy="909320"/>
          </a:xfrm>
          <a:prstGeom prst="rect">
            <a:avLst/>
          </a:prstGeom>
        </p:spPr>
      </p:pic>
      <p:sp>
        <p:nvSpPr>
          <p:cNvPr id="30" name="CaixaDeTexto 29">
            <a:extLst>
              <a:ext uri="{FF2B5EF4-FFF2-40B4-BE49-F238E27FC236}">
                <a16:creationId xmlns:a16="http://schemas.microsoft.com/office/drawing/2014/main" id="{800B5CAA-AFCE-2B6C-62F2-F6CF2E34B479}"/>
              </a:ext>
            </a:extLst>
          </p:cNvPr>
          <p:cNvSpPr txBox="1"/>
          <p:nvPr/>
        </p:nvSpPr>
        <p:spPr>
          <a:xfrm>
            <a:off x="585402" y="973058"/>
            <a:ext cx="8915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>
                <a:solidFill>
                  <a:schemeClr val="bg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N = 6</a:t>
            </a:r>
          </a:p>
        </p:txBody>
      </p:sp>
      <p:sp>
        <p:nvSpPr>
          <p:cNvPr id="31" name="Seta: para a Direita 30">
            <a:extLst>
              <a:ext uri="{FF2B5EF4-FFF2-40B4-BE49-F238E27FC236}">
                <a16:creationId xmlns:a16="http://schemas.microsoft.com/office/drawing/2014/main" id="{1A2F1DC4-1C6A-01F2-842C-134BFF7984E8}"/>
              </a:ext>
            </a:extLst>
          </p:cNvPr>
          <p:cNvSpPr/>
          <p:nvPr/>
        </p:nvSpPr>
        <p:spPr>
          <a:xfrm>
            <a:off x="1668980" y="1011174"/>
            <a:ext cx="262890" cy="221742"/>
          </a:xfrm>
          <a:prstGeom prst="rightArrow">
            <a:avLst/>
          </a:prstGeom>
          <a:solidFill>
            <a:srgbClr val="D4434A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Imagem 32" descr="Forma&#10;&#10;Descrição gerada automaticamente com confiança média">
            <a:extLst>
              <a:ext uri="{FF2B5EF4-FFF2-40B4-BE49-F238E27FC236}">
                <a16:creationId xmlns:a16="http://schemas.microsoft.com/office/drawing/2014/main" id="{8A4A6529-84DD-A652-93D0-563E2D790DE9}"/>
              </a:ext>
            </a:extLst>
          </p:cNvPr>
          <p:cNvPicPr>
            <a:picLocks noChangeAspect="1"/>
          </p:cNvPicPr>
          <p:nvPr/>
        </p:nvPicPr>
        <p:blipFill>
          <a:blip r:embed="rId5">
            <a:duotone>
              <a:prstClr val="black"/>
              <a:srgbClr val="C00000">
                <a:tint val="45000"/>
                <a:satMod val="400000"/>
              </a:srgbClr>
            </a:duotone>
            <a:alphaModFix amt="50000"/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6"/>
              </a:ext>
            </a:extLst>
          </a:blip>
          <a:stretch>
            <a:fillRect/>
          </a:stretch>
        </p:blipFill>
        <p:spPr>
          <a:xfrm>
            <a:off x="2116913" y="618209"/>
            <a:ext cx="1810624" cy="1063562"/>
          </a:xfrm>
          <a:prstGeom prst="rect">
            <a:avLst/>
          </a:prstGeom>
        </p:spPr>
      </p:pic>
      <p:sp>
        <p:nvSpPr>
          <p:cNvPr id="34" name="CaixaDeTexto 33">
            <a:extLst>
              <a:ext uri="{FF2B5EF4-FFF2-40B4-BE49-F238E27FC236}">
                <a16:creationId xmlns:a16="http://schemas.microsoft.com/office/drawing/2014/main" id="{AF3B5967-7F03-05A3-FBBE-78DC89C5D695}"/>
              </a:ext>
            </a:extLst>
          </p:cNvPr>
          <p:cNvSpPr txBox="1"/>
          <p:nvPr/>
        </p:nvSpPr>
        <p:spPr>
          <a:xfrm>
            <a:off x="2505316" y="999155"/>
            <a:ext cx="10145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 err="1">
                <a:solidFill>
                  <a:schemeClr val="bg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Hydroge</a:t>
            </a:r>
            <a:r>
              <a:rPr lang="pt-BR" sz="1000" dirty="0" err="1">
                <a:solidFill>
                  <a:schemeClr val="bg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l</a:t>
            </a:r>
            <a:endParaRPr lang="pt-BR" sz="1000" dirty="0">
              <a:solidFill>
                <a:schemeClr val="bg1"/>
              </a:solidFill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Seta: para a Direita 34">
            <a:extLst>
              <a:ext uri="{FF2B5EF4-FFF2-40B4-BE49-F238E27FC236}">
                <a16:creationId xmlns:a16="http://schemas.microsoft.com/office/drawing/2014/main" id="{7725150C-F4FB-68D6-F7F1-26F153D01EDE}"/>
              </a:ext>
            </a:extLst>
          </p:cNvPr>
          <p:cNvSpPr/>
          <p:nvPr/>
        </p:nvSpPr>
        <p:spPr>
          <a:xfrm>
            <a:off x="4032183" y="1028954"/>
            <a:ext cx="262890" cy="221742"/>
          </a:xfrm>
          <a:prstGeom prst="rightArrow">
            <a:avLst/>
          </a:prstGeom>
          <a:solidFill>
            <a:srgbClr val="D4434A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tângulo: Cantos Arredondados 35">
            <a:extLst>
              <a:ext uri="{FF2B5EF4-FFF2-40B4-BE49-F238E27FC236}">
                <a16:creationId xmlns:a16="http://schemas.microsoft.com/office/drawing/2014/main" id="{F37A9E8A-15E9-B122-F575-6034007515F6}"/>
              </a:ext>
            </a:extLst>
          </p:cNvPr>
          <p:cNvSpPr/>
          <p:nvPr/>
        </p:nvSpPr>
        <p:spPr>
          <a:xfrm>
            <a:off x="4421989" y="737896"/>
            <a:ext cx="1324563" cy="288686"/>
          </a:xfrm>
          <a:prstGeom prst="roundRect">
            <a:avLst/>
          </a:prstGeom>
          <a:solidFill>
            <a:srgbClr val="FFCAC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1400" dirty="0" err="1">
                <a:solidFill>
                  <a:schemeClr val="tx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Termography</a:t>
            </a:r>
            <a:endParaRPr lang="pt-BR" sz="1400" dirty="0">
              <a:solidFill>
                <a:schemeClr val="tx1"/>
              </a:solidFill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Seta: para a Direita 39">
            <a:extLst>
              <a:ext uri="{FF2B5EF4-FFF2-40B4-BE49-F238E27FC236}">
                <a16:creationId xmlns:a16="http://schemas.microsoft.com/office/drawing/2014/main" id="{DE592CC4-D58E-0E0C-2F31-DC0F78785643}"/>
              </a:ext>
            </a:extLst>
          </p:cNvPr>
          <p:cNvSpPr/>
          <p:nvPr/>
        </p:nvSpPr>
        <p:spPr>
          <a:xfrm>
            <a:off x="7363270" y="1036879"/>
            <a:ext cx="262890" cy="221742"/>
          </a:xfrm>
          <a:prstGeom prst="rightArrow">
            <a:avLst/>
          </a:prstGeom>
          <a:solidFill>
            <a:srgbClr val="D4434A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Seta: para a Direita 59">
            <a:extLst>
              <a:ext uri="{FF2B5EF4-FFF2-40B4-BE49-F238E27FC236}">
                <a16:creationId xmlns:a16="http://schemas.microsoft.com/office/drawing/2014/main" id="{B6D95370-0372-F561-2553-70961F41BF44}"/>
              </a:ext>
            </a:extLst>
          </p:cNvPr>
          <p:cNvSpPr/>
          <p:nvPr/>
        </p:nvSpPr>
        <p:spPr>
          <a:xfrm>
            <a:off x="9697674" y="1017497"/>
            <a:ext cx="262890" cy="221742"/>
          </a:xfrm>
          <a:prstGeom prst="rightArrow">
            <a:avLst/>
          </a:prstGeom>
          <a:solidFill>
            <a:srgbClr val="D4434A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tângulo: Cantos Arredondados 2">
            <a:extLst>
              <a:ext uri="{FF2B5EF4-FFF2-40B4-BE49-F238E27FC236}">
                <a16:creationId xmlns:a16="http://schemas.microsoft.com/office/drawing/2014/main" id="{D829340A-D025-968A-CA29-87BF8A118724}"/>
              </a:ext>
            </a:extLst>
          </p:cNvPr>
          <p:cNvSpPr/>
          <p:nvPr/>
        </p:nvSpPr>
        <p:spPr>
          <a:xfrm>
            <a:off x="453019" y="1858098"/>
            <a:ext cx="2443572" cy="1683621"/>
          </a:xfrm>
          <a:prstGeom prst="roundRect">
            <a:avLst>
              <a:gd name="adj" fmla="val 7377"/>
            </a:avLst>
          </a:prstGeom>
          <a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 t="-4000" b="-4000"/>
            </a:stretch>
          </a:blipFill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endParaRPr lang="pt-BR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tângulo: Cantos Arredondados 4">
            <a:extLst>
              <a:ext uri="{FF2B5EF4-FFF2-40B4-BE49-F238E27FC236}">
                <a16:creationId xmlns:a16="http://schemas.microsoft.com/office/drawing/2014/main" id="{4545C11B-6795-9DA8-25AA-1517861C6394}"/>
              </a:ext>
            </a:extLst>
          </p:cNvPr>
          <p:cNvSpPr/>
          <p:nvPr/>
        </p:nvSpPr>
        <p:spPr>
          <a:xfrm>
            <a:off x="3464487" y="1858098"/>
            <a:ext cx="2443572" cy="1683621"/>
          </a:xfrm>
          <a:prstGeom prst="roundRect">
            <a:avLst>
              <a:gd name="adj" fmla="val 7377"/>
            </a:avLst>
          </a:prstGeom>
          <a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 t="-8000" b="-8000"/>
            </a:stretch>
          </a:blipFill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endParaRPr lang="pt-BR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tângulo: Cantos Arredondados 12">
            <a:extLst>
              <a:ext uri="{FF2B5EF4-FFF2-40B4-BE49-F238E27FC236}">
                <a16:creationId xmlns:a16="http://schemas.microsoft.com/office/drawing/2014/main" id="{91D2867F-540D-226C-DF55-5B70B8BED35A}"/>
              </a:ext>
            </a:extLst>
          </p:cNvPr>
          <p:cNvSpPr/>
          <p:nvPr/>
        </p:nvSpPr>
        <p:spPr>
          <a:xfrm>
            <a:off x="6525159" y="1882812"/>
            <a:ext cx="2443572" cy="1683621"/>
          </a:xfrm>
          <a:prstGeom prst="roundRect">
            <a:avLst>
              <a:gd name="adj" fmla="val 4518"/>
            </a:avLst>
          </a:prstGeom>
          <a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 t="-1000" b="-1000"/>
            </a:stretch>
          </a:blipFill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endParaRPr lang="pt-BR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tângulo: Cantos Arredondados 22">
            <a:extLst>
              <a:ext uri="{FF2B5EF4-FFF2-40B4-BE49-F238E27FC236}">
                <a16:creationId xmlns:a16="http://schemas.microsoft.com/office/drawing/2014/main" id="{2F2DDBBA-4BED-74A4-C2D3-9F9169EFCEEF}"/>
              </a:ext>
            </a:extLst>
          </p:cNvPr>
          <p:cNvSpPr/>
          <p:nvPr/>
        </p:nvSpPr>
        <p:spPr>
          <a:xfrm>
            <a:off x="9585832" y="1850465"/>
            <a:ext cx="2443572" cy="1683621"/>
          </a:xfrm>
          <a:prstGeom prst="roundRect">
            <a:avLst>
              <a:gd name="adj" fmla="val 10950"/>
            </a:avLst>
          </a:prstGeom>
          <a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 l="-2000" r="-2000"/>
            </a:stretch>
          </a:blipFill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endParaRPr lang="pt-BR" dirty="0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tângulo: Cantos Arredondados 41">
            <a:extLst>
              <a:ext uri="{FF2B5EF4-FFF2-40B4-BE49-F238E27FC236}">
                <a16:creationId xmlns:a16="http://schemas.microsoft.com/office/drawing/2014/main" id="{5F4D9F88-1DB7-F51F-40B6-59AD91915045}"/>
              </a:ext>
            </a:extLst>
          </p:cNvPr>
          <p:cNvSpPr/>
          <p:nvPr/>
        </p:nvSpPr>
        <p:spPr>
          <a:xfrm>
            <a:off x="5908059" y="734025"/>
            <a:ext cx="1324563" cy="288686"/>
          </a:xfrm>
          <a:prstGeom prst="roundRect">
            <a:avLst/>
          </a:prstGeom>
          <a:solidFill>
            <a:srgbClr val="FFCAC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1400" dirty="0">
                <a:solidFill>
                  <a:schemeClr val="tx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Von Frey</a:t>
            </a:r>
          </a:p>
        </p:txBody>
      </p:sp>
      <p:sp>
        <p:nvSpPr>
          <p:cNvPr id="43" name="Retângulo: Cantos Arredondados 42">
            <a:extLst>
              <a:ext uri="{FF2B5EF4-FFF2-40B4-BE49-F238E27FC236}">
                <a16:creationId xmlns:a16="http://schemas.microsoft.com/office/drawing/2014/main" id="{F664B062-4B9D-2C01-D20C-95970E25C901}"/>
              </a:ext>
            </a:extLst>
          </p:cNvPr>
          <p:cNvSpPr/>
          <p:nvPr/>
        </p:nvSpPr>
        <p:spPr>
          <a:xfrm>
            <a:off x="5143160" y="1137654"/>
            <a:ext cx="1324563" cy="288686"/>
          </a:xfrm>
          <a:prstGeom prst="roundRect">
            <a:avLst/>
          </a:prstGeom>
          <a:solidFill>
            <a:srgbClr val="FFCAC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1200" dirty="0" err="1">
                <a:solidFill>
                  <a:schemeClr val="tx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Physical</a:t>
            </a:r>
            <a:r>
              <a:rPr lang="pt-BR" sz="1200" dirty="0">
                <a:solidFill>
                  <a:schemeClr val="tx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 </a:t>
            </a:r>
            <a:r>
              <a:rPr lang="pt-BR" sz="1200" dirty="0" err="1">
                <a:solidFill>
                  <a:schemeClr val="tx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Exam</a:t>
            </a:r>
            <a:endParaRPr lang="pt-BR" sz="1200" dirty="0">
              <a:solidFill>
                <a:schemeClr val="tx1"/>
              </a:solidFill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tângulo: Cantos Arredondados 43">
            <a:extLst>
              <a:ext uri="{FF2B5EF4-FFF2-40B4-BE49-F238E27FC236}">
                <a16:creationId xmlns:a16="http://schemas.microsoft.com/office/drawing/2014/main" id="{F0F0420F-59AA-8667-FD3C-35E5BB175A9E}"/>
              </a:ext>
            </a:extLst>
          </p:cNvPr>
          <p:cNvSpPr/>
          <p:nvPr/>
        </p:nvSpPr>
        <p:spPr>
          <a:xfrm>
            <a:off x="10197789" y="748193"/>
            <a:ext cx="672047" cy="288686"/>
          </a:xfrm>
          <a:prstGeom prst="roundRect">
            <a:avLst/>
          </a:prstGeom>
          <a:solidFill>
            <a:srgbClr val="FFCAC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1400" dirty="0">
                <a:solidFill>
                  <a:schemeClr val="tx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IHC</a:t>
            </a:r>
          </a:p>
        </p:txBody>
      </p:sp>
      <p:sp>
        <p:nvSpPr>
          <p:cNvPr id="45" name="Retângulo: Cantos Arredondados 44">
            <a:extLst>
              <a:ext uri="{FF2B5EF4-FFF2-40B4-BE49-F238E27FC236}">
                <a16:creationId xmlns:a16="http://schemas.microsoft.com/office/drawing/2014/main" id="{478CBC09-A2D0-C3B2-5F3D-F6DCC7476D0A}"/>
              </a:ext>
            </a:extLst>
          </p:cNvPr>
          <p:cNvSpPr/>
          <p:nvPr/>
        </p:nvSpPr>
        <p:spPr>
          <a:xfrm>
            <a:off x="10225728" y="1155501"/>
            <a:ext cx="1584983" cy="288686"/>
          </a:xfrm>
          <a:prstGeom prst="roundRect">
            <a:avLst/>
          </a:prstGeom>
          <a:solidFill>
            <a:srgbClr val="FFCAC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1400" dirty="0" err="1">
                <a:solidFill>
                  <a:schemeClr val="tx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Histopathology</a:t>
            </a:r>
            <a:endParaRPr lang="pt-BR" sz="1400" dirty="0">
              <a:solidFill>
                <a:schemeClr val="tx1"/>
              </a:solidFill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tângulo: Cantos Arredondados 46">
            <a:extLst>
              <a:ext uri="{FF2B5EF4-FFF2-40B4-BE49-F238E27FC236}">
                <a16:creationId xmlns:a16="http://schemas.microsoft.com/office/drawing/2014/main" id="{C6E08B69-197A-5792-8D63-B830DED0FDBA}"/>
              </a:ext>
            </a:extLst>
          </p:cNvPr>
          <p:cNvSpPr/>
          <p:nvPr/>
        </p:nvSpPr>
        <p:spPr>
          <a:xfrm>
            <a:off x="11138664" y="740739"/>
            <a:ext cx="672047" cy="288686"/>
          </a:xfrm>
          <a:prstGeom prst="roundRect">
            <a:avLst/>
          </a:prstGeom>
          <a:solidFill>
            <a:srgbClr val="FFCAC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1400" dirty="0">
                <a:solidFill>
                  <a:schemeClr val="tx1"/>
                </a:solidFill>
                <a:latin typeface="Arial Nova" panose="020B0504020202020204" pitchFamily="34" charset="0"/>
                <a:cs typeface="Arial" panose="020B0604020202020204" pitchFamily="34" charset="0"/>
              </a:rPr>
              <a:t>MET</a:t>
            </a:r>
          </a:p>
        </p:txBody>
      </p:sp>
      <p:pic>
        <p:nvPicPr>
          <p:cNvPr id="1030" name="Picture 6" descr="Biopsy - Free medical icons">
            <a:extLst>
              <a:ext uri="{FF2B5EF4-FFF2-40B4-BE49-F238E27FC236}">
                <a16:creationId xmlns:a16="http://schemas.microsoft.com/office/drawing/2014/main" id="{901CC9F2-ECC0-B292-038E-1A16B8BDEE5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61668" y="835440"/>
            <a:ext cx="695162" cy="6951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Biopsy - Free medical icons">
            <a:extLst>
              <a:ext uri="{FF2B5EF4-FFF2-40B4-BE49-F238E27FC236}">
                <a16:creationId xmlns:a16="http://schemas.microsoft.com/office/drawing/2014/main" id="{5CB754FA-457D-B0BA-9080-A35E7C9494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7840" y="835440"/>
            <a:ext cx="667481" cy="6674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4" name="Retângulo 63">
            <a:extLst>
              <a:ext uri="{FF2B5EF4-FFF2-40B4-BE49-F238E27FC236}">
                <a16:creationId xmlns:a16="http://schemas.microsoft.com/office/drawing/2014/main" id="{059433DB-294D-EE7E-4E1D-458878341916}"/>
              </a:ext>
            </a:extLst>
          </p:cNvPr>
          <p:cNvSpPr/>
          <p:nvPr/>
        </p:nvSpPr>
        <p:spPr>
          <a:xfrm>
            <a:off x="453019" y="3492451"/>
            <a:ext cx="2443572" cy="906565"/>
          </a:xfrm>
          <a:prstGeom prst="rect">
            <a:avLst/>
          </a:pr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/>
          <a:lstStyle/>
          <a:p>
            <a:endParaRPr lang="pt-BR"/>
          </a:p>
        </p:txBody>
      </p:sp>
      <p:sp>
        <p:nvSpPr>
          <p:cNvPr id="65" name="CaixaDeTexto 64">
            <a:extLst>
              <a:ext uri="{FF2B5EF4-FFF2-40B4-BE49-F238E27FC236}">
                <a16:creationId xmlns:a16="http://schemas.microsoft.com/office/drawing/2014/main" id="{279F26F3-6795-9520-D18D-95ABBA79A07D}"/>
              </a:ext>
            </a:extLst>
          </p:cNvPr>
          <p:cNvSpPr txBox="1"/>
          <p:nvPr/>
        </p:nvSpPr>
        <p:spPr>
          <a:xfrm>
            <a:off x="274927" y="3492451"/>
            <a:ext cx="2666361" cy="906565"/>
          </a:xfrm>
          <a:prstGeom prst="rect">
            <a:avLst/>
          </a:prstGeom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113792" tIns="113792" rIns="113792" bIns="0" numCol="1" spcCol="1270" anchor="t" anchorCtr="0">
            <a:noAutofit/>
          </a:bodyPr>
          <a:lstStyle/>
          <a:p>
            <a:pPr marL="0" lvl="0" indent="0" algn="ctr" defTabSz="7112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400" kern="12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temperature increase was observed 6- and 12-hours post-application.</a:t>
            </a:r>
            <a:endParaRPr lang="pt-BR" sz="1400" kern="1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62" name="Retângulo 61">
            <a:extLst>
              <a:ext uri="{FF2B5EF4-FFF2-40B4-BE49-F238E27FC236}">
                <a16:creationId xmlns:a16="http://schemas.microsoft.com/office/drawing/2014/main" id="{797425C0-FD69-5B2E-FC1A-15A3CA07FE4D}"/>
              </a:ext>
            </a:extLst>
          </p:cNvPr>
          <p:cNvSpPr/>
          <p:nvPr/>
        </p:nvSpPr>
        <p:spPr>
          <a:xfrm>
            <a:off x="3141051" y="3492451"/>
            <a:ext cx="2443572" cy="906565"/>
          </a:xfrm>
          <a:prstGeom prst="rect">
            <a:avLst/>
          </a:pr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/>
          <a:lstStyle/>
          <a:p>
            <a:endParaRPr lang="pt-BR"/>
          </a:p>
        </p:txBody>
      </p:sp>
      <p:sp>
        <p:nvSpPr>
          <p:cNvPr id="57" name="Retângulo 56">
            <a:extLst>
              <a:ext uri="{FF2B5EF4-FFF2-40B4-BE49-F238E27FC236}">
                <a16:creationId xmlns:a16="http://schemas.microsoft.com/office/drawing/2014/main" id="{036A5AAC-6421-810F-2E9A-E04CACED7F7E}"/>
              </a:ext>
            </a:extLst>
          </p:cNvPr>
          <p:cNvSpPr/>
          <p:nvPr/>
        </p:nvSpPr>
        <p:spPr>
          <a:xfrm>
            <a:off x="5867862" y="3448012"/>
            <a:ext cx="2443572" cy="906565"/>
          </a:xfrm>
          <a:prstGeom prst="rect">
            <a:avLst/>
          </a:pr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/>
          <a:lstStyle/>
          <a:p>
            <a:endParaRPr lang="pt-BR"/>
          </a:p>
        </p:txBody>
      </p:sp>
      <p:sp>
        <p:nvSpPr>
          <p:cNvPr id="56" name="CaixaDeTexto 55">
            <a:extLst>
              <a:ext uri="{FF2B5EF4-FFF2-40B4-BE49-F238E27FC236}">
                <a16:creationId xmlns:a16="http://schemas.microsoft.com/office/drawing/2014/main" id="{AE6F4936-D5AD-8DE2-4073-65CDDEB24020}"/>
              </a:ext>
            </a:extLst>
          </p:cNvPr>
          <p:cNvSpPr txBox="1"/>
          <p:nvPr/>
        </p:nvSpPr>
        <p:spPr>
          <a:xfrm>
            <a:off x="9570934" y="3565367"/>
            <a:ext cx="2443572" cy="906565"/>
          </a:xfrm>
          <a:prstGeom prst="rect">
            <a:avLst/>
          </a:prstGeom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92456" tIns="92456" rIns="92456" bIns="0" numCol="1" spcCol="1270" anchor="t" anchorCtr="0">
            <a:noAutofit/>
          </a:bodyPr>
          <a:lstStyle/>
          <a:p>
            <a:pPr marL="0" lvl="0" indent="0" algn="ctr" defTabSz="5778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pt-BR" sz="1400" kern="12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 d: </a:t>
            </a:r>
            <a:r>
              <a:rPr lang="pt-BR" sz="1400" kern="12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creased</a:t>
            </a:r>
            <a:r>
              <a:rPr lang="pt-BR" sz="1400" kern="12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400" kern="12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pt-BR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400" kern="12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iltration</a:t>
            </a:r>
            <a:r>
              <a:rPr lang="pt-BR" sz="1400" kern="12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kern="12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regenerated regions </a:t>
            </a:r>
            <a:endParaRPr lang="pt-BR" sz="1400" kern="1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66" name="CaixaDeTexto 65">
            <a:extLst>
              <a:ext uri="{FF2B5EF4-FFF2-40B4-BE49-F238E27FC236}">
                <a16:creationId xmlns:a16="http://schemas.microsoft.com/office/drawing/2014/main" id="{BF1DF6F4-B2DC-8D71-ACFB-DB0AC61EDD9E}"/>
              </a:ext>
            </a:extLst>
          </p:cNvPr>
          <p:cNvSpPr txBox="1"/>
          <p:nvPr/>
        </p:nvSpPr>
        <p:spPr>
          <a:xfrm>
            <a:off x="3396440" y="3569751"/>
            <a:ext cx="2643334" cy="906565"/>
          </a:xfrm>
          <a:prstGeom prst="rect">
            <a:avLst/>
          </a:prstGeom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113792" tIns="113792" rIns="113792" bIns="0" numCol="1" spcCol="1270" anchor="t" anchorCtr="0">
            <a:noAutofit/>
          </a:bodyPr>
          <a:lstStyle/>
          <a:p>
            <a:pPr marL="0" lvl="0" indent="0" algn="ctr" defTabSz="7112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400" kern="12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discernible increase in local sensitivity was noted</a:t>
            </a:r>
            <a:endParaRPr lang="pt-BR" sz="1400" kern="1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67" name="CaixaDeTexto 66">
            <a:extLst>
              <a:ext uri="{FF2B5EF4-FFF2-40B4-BE49-F238E27FC236}">
                <a16:creationId xmlns:a16="http://schemas.microsoft.com/office/drawing/2014/main" id="{30F61268-E578-E3A0-D0CA-9CEE26F7E17F}"/>
              </a:ext>
            </a:extLst>
          </p:cNvPr>
          <p:cNvSpPr txBox="1"/>
          <p:nvPr/>
        </p:nvSpPr>
        <p:spPr>
          <a:xfrm>
            <a:off x="6323013" y="3598348"/>
            <a:ext cx="2922308" cy="906565"/>
          </a:xfrm>
          <a:prstGeom prst="rect">
            <a:avLst/>
          </a:prstGeom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78232" tIns="78232" rIns="78232" bIns="0" numCol="1" spcCol="1270" anchor="t" anchorCtr="0">
            <a:noAutofit/>
          </a:bodyPr>
          <a:lstStyle/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pt-BR" sz="1400" kern="12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7 d: </a:t>
            </a:r>
            <a:r>
              <a:rPr lang="en-US" sz="1400" kern="12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dritic cells surrounded by biomaterial</a:t>
            </a:r>
          </a:p>
        </p:txBody>
      </p:sp>
      <p:cxnSp>
        <p:nvCxnSpPr>
          <p:cNvPr id="69" name="Conector reto 68">
            <a:extLst>
              <a:ext uri="{FF2B5EF4-FFF2-40B4-BE49-F238E27FC236}">
                <a16:creationId xmlns:a16="http://schemas.microsoft.com/office/drawing/2014/main" id="{D5417E03-8724-7187-5EB8-90D4FC5929B4}"/>
              </a:ext>
            </a:extLst>
          </p:cNvPr>
          <p:cNvCxnSpPr>
            <a:cxnSpLocks/>
          </p:cNvCxnSpPr>
          <p:nvPr/>
        </p:nvCxnSpPr>
        <p:spPr>
          <a:xfrm>
            <a:off x="262570" y="1718842"/>
            <a:ext cx="11995332" cy="0"/>
          </a:xfrm>
          <a:prstGeom prst="line">
            <a:avLst/>
          </a:prstGeom>
          <a:ln>
            <a:solidFill>
              <a:srgbClr val="D4434A"/>
            </a:solidFill>
            <a:prstDash val="dash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724531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80</TotalTime>
  <Words>95</Words>
  <Application>Microsoft Office PowerPoint</Application>
  <PresentationFormat>Personalizar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Arial Nova</vt:lpstr>
      <vt:lpstr>Calibri</vt:lpstr>
      <vt:lpstr>Calibri Light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THIAGO DE CASTILHO LIMA</dc:creator>
  <cp:lastModifiedBy>Nilton José dos Santos</cp:lastModifiedBy>
  <cp:revision>6</cp:revision>
  <dcterms:created xsi:type="dcterms:W3CDTF">2023-08-22T22:37:03Z</dcterms:created>
  <dcterms:modified xsi:type="dcterms:W3CDTF">2023-08-24T02:44:58Z</dcterms:modified>
</cp:coreProperties>
</file>